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8340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83200" cy="9907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98800" y="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55680" y="742680"/>
            <a:ext cx="2571840" cy="37148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8680" y="4704840"/>
            <a:ext cx="5505480" cy="4457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0896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98800" y="9408960"/>
            <a:ext cx="2982960" cy="49536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27000"/>
                <a:tab algn="l" pos="1854360"/>
                <a:tab algn="l" pos="2781360"/>
                <a:tab algn="l" pos="3708360"/>
                <a:tab algn="l" pos="4635360"/>
                <a:tab algn="l" pos="5562720"/>
                <a:tab algn="l" pos="6489720"/>
                <a:tab algn="l" pos="7416720"/>
                <a:tab algn="l" pos="8344080"/>
                <a:tab algn="l" pos="9271080"/>
                <a:tab algn="l" pos="10198080"/>
              </a:tabLst>
            </a:pPr>
            <a:fld id="{DC6F521F-7750-4273-A306-818EFF9A09C5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2155680" y="743040"/>
            <a:ext cx="2571840" cy="371484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8680" y="4704840"/>
            <a:ext cx="5505480" cy="4457880"/>
          </a:xfrm>
          <a:prstGeom prst="rect">
            <a:avLst/>
          </a:prstGeom>
          <a:noFill/>
          <a:ln w="0">
            <a:noFill/>
          </a:ln>
        </p:spPr>
        <p:txBody>
          <a:bodyPr lIns="92880" rIns="9288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</a:rPr>
              <a:t>QUIMIOTRIPSI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5067CB-DE50-412A-BADF-95C4ABABDE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3D17E-A23F-4788-B207-F7A8C77107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3294D-83E2-4115-8558-6844F7F4D8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0717E-E339-4D4E-B880-2DF2EB9CC2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B3377-2A4F-493E-A315-0E0E545A26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387D79-0961-43A5-A733-8A54F65AF1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207DF-453F-4D54-8A80-F28748DA97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5B9D8-83AA-47E7-9B1D-B1650044F9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9383AE-88F6-4BD3-9ABA-3CD42DE1EA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E97E3-1759-438E-859F-0B5E02ABE6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82A8E-7A31-4C3C-BB51-D4A7681A8E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E8A48-6B6A-4B58-90B5-C5DB231D39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7EE5B6-14D5-4AEE-B869-102C3FC74FE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404640" y="272880"/>
            <a:ext cx="6297840" cy="211464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4464720" y="920880"/>
            <a:ext cx="218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 [M+2H]: 695.81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4581360" y="1136520"/>
            <a:ext cx="21600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1915920" y="272880"/>
            <a:ext cx="21564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135880" y="128520"/>
            <a:ext cx="215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[M+3H]: 464.21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7160" y="128160"/>
            <a:ext cx="586080" cy="215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54-C7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2"/>
          <a:stretch/>
        </p:blipFill>
        <p:spPr>
          <a:xfrm>
            <a:off x="333360" y="2692440"/>
            <a:ext cx="6297480" cy="211608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4393080" y="3916440"/>
            <a:ext cx="218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 [M+3H]: 729.30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5373720" y="4132440"/>
            <a:ext cx="216000" cy="21564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1700280" y="4132440"/>
            <a:ext cx="216000" cy="21564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991160" y="3772080"/>
            <a:ext cx="215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[M+4H]: 547.23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7520" y="2547360"/>
            <a:ext cx="642600" cy="215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65-C1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" descr=""/>
          <p:cNvPicPr/>
          <p:nvPr/>
        </p:nvPicPr>
        <p:blipFill>
          <a:blip r:embed="rId3"/>
          <a:stretch/>
        </p:blipFill>
        <p:spPr>
          <a:xfrm>
            <a:off x="404640" y="5213520"/>
            <a:ext cx="6297840" cy="211608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4624920" y="5788080"/>
            <a:ext cx="218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 [M+3H]: 921.45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5877000" y="6105600"/>
            <a:ext cx="21600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1628640" y="5168880"/>
            <a:ext cx="216000" cy="216000"/>
          </a:xfrm>
          <a:prstGeom prst="line">
            <a:avLst/>
          </a:prstGeom>
          <a:ln w="9360">
            <a:solidFill>
              <a:srgbClr val="ff5050"/>
            </a:solidFill>
            <a:miter/>
            <a:tailEnd len="lg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775520" y="5097600"/>
            <a:ext cx="215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000" spc="-1" strike="noStrike">
                <a:solidFill>
                  <a:srgbClr val="000000"/>
                </a:solidFill>
                <a:latin typeface="Arial"/>
              </a:rPr>
              <a:t>Expected mass[M+4H]: 691.34D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19160" y="5023800"/>
            <a:ext cx="642600" cy="215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98-C1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3T16:34:51Z</dcterms:created>
  <dc:creator>Administrator</dc:creator>
  <dc:description/>
  <dc:language>en-US</dc:language>
  <cp:lastModifiedBy>Daniel Maragno Trindade</cp:lastModifiedBy>
  <dcterms:modified xsi:type="dcterms:W3CDTF">2009-03-17T11:46:27Z</dcterms:modified>
  <cp:revision>10</cp:revision>
  <dc:subject/>
  <dc:title>Slide 1</dc:title>
</cp:coreProperties>
</file>